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7" r:id="rId2"/>
    <p:sldId id="263" r:id="rId3"/>
    <p:sldId id="266" r:id="rId4"/>
    <p:sldId id="256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94"/>
  </p:normalViewPr>
  <p:slideViewPr>
    <p:cSldViewPr snapToGrid="0" snapToObjects="1">
      <p:cViewPr varScale="1">
        <p:scale>
          <a:sx n="104" d="100"/>
          <a:sy n="104" d="100"/>
        </p:scale>
        <p:origin x="232" y="7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58AA70-1084-EC41-9826-7DE2B97B2333}" type="datetimeFigureOut">
              <a:rPr kumimoji="1" lang="ja-JP" altLang="en-US" smtClean="0"/>
              <a:t>2020/12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86F444-5BD8-0E4A-833E-F0225DA12F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4359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48B181-17B3-B049-A6B5-BCBDD211C8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3391ED7-5B1E-9245-B4E1-4F9F138CDE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CEEE82-5389-A245-92C4-FBCDF4819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EB536-D259-9048-9088-3A233BBF8A0E}" type="datetimeFigureOut">
              <a:rPr kumimoji="1" lang="ja-JP" altLang="en-US" smtClean="0"/>
              <a:t>2020/1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9DEC839-349B-3E40-96F3-B48656467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11C6A5-669A-724C-BBA8-08E50981B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4E394-9A5B-9741-A24D-FD8C5FDA76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9008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A78D37-FEEF-B843-AA7B-79F67F214B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1CB2435-7F8B-CA44-909B-ABA0AC0EE2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1B063C9-6FF9-B54A-98A2-B59124AA6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EB536-D259-9048-9088-3A233BBF8A0E}" type="datetimeFigureOut">
              <a:rPr kumimoji="1" lang="ja-JP" altLang="en-US" smtClean="0"/>
              <a:t>2020/1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F099EF2-1913-7D4D-A33C-8E27128612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0C862FE-1323-2344-A358-B825D53E8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4E394-9A5B-9741-A24D-FD8C5FDA76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980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3D010DF-0FCA-9140-8677-5D176FEE28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A16515F-5C4E-E042-B295-0562A397D2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E0212B7-E1D5-6540-96BB-C84CDB898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EB536-D259-9048-9088-3A233BBF8A0E}" type="datetimeFigureOut">
              <a:rPr kumimoji="1" lang="ja-JP" altLang="en-US" smtClean="0"/>
              <a:t>2020/1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BB2EFF5-3DEC-814A-A2C9-C8B852013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B198496-896F-6349-87E6-074BBC6F41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4E394-9A5B-9741-A24D-FD8C5FDA76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1769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44A800-1B62-0643-BCA4-C6F0B241AF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1BBCC40-D7F2-AC49-AAAC-47620221EE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A425B6-90A5-5042-86C6-6C7CABA16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EB536-D259-9048-9088-3A233BBF8A0E}" type="datetimeFigureOut">
              <a:rPr kumimoji="1" lang="ja-JP" altLang="en-US" smtClean="0"/>
              <a:t>2020/1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9BB19D-0E2A-F144-A403-A8F97F927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5164AD3-5274-0540-9F3D-0A8232240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4E394-9A5B-9741-A24D-FD8C5FDA76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9718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FA3BCB-06C0-C44C-AA29-CABA495483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DE52DFB-A753-EA40-8960-5D99F1290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1007B1-A19F-464F-AE1F-42D9B116F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EB536-D259-9048-9088-3A233BBF8A0E}" type="datetimeFigureOut">
              <a:rPr kumimoji="1" lang="ja-JP" altLang="en-US" smtClean="0"/>
              <a:t>2020/1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AC163F4-5A6E-D04F-B57B-FED441FDF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FE0F5F-C8E0-C84D-81C8-1BD7D59E7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4E394-9A5B-9741-A24D-FD8C5FDA76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2588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8B092A-62D9-5B4E-AFCA-BFDED9E5B0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0561C80-3CDE-CD4A-A7B8-550D44FE9F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0F8D17D-459D-3A41-ADC2-E9A7A58A13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B159541-4300-EE4C-A0D2-08E7201F27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EB536-D259-9048-9088-3A233BBF8A0E}" type="datetimeFigureOut">
              <a:rPr kumimoji="1" lang="ja-JP" altLang="en-US" smtClean="0"/>
              <a:t>2020/1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2A4A224-35F2-AC4F-AB0D-0D403DC600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840A9F0-52FF-4D4C-B82D-81E5A10B8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4E394-9A5B-9741-A24D-FD8C5FDA76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8825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0BE05A-A672-604E-89AA-7D7E339D6C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8B3678B-3D81-B84B-AC78-AB841EE367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0FB3A76-8564-A841-8237-79FE09E773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93B9927-C4D8-744B-AACE-06CF694B01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00746E8-1AA9-E843-BC83-35AE45AE4E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6673E3C-5B27-D340-A5C5-8CEFF84DB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EB536-D259-9048-9088-3A233BBF8A0E}" type="datetimeFigureOut">
              <a:rPr kumimoji="1" lang="ja-JP" altLang="en-US" smtClean="0"/>
              <a:t>2020/12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A2ACD44-2DD3-954C-8208-1C18C5E2F0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DE174A3-89DB-7B45-AB0A-A2DD603D9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4E394-9A5B-9741-A24D-FD8C5FDA76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7339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B6C72D-9F9E-AD41-9003-2B784C1666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756D037-F6D8-FE4D-B05D-FA83C5242F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EB536-D259-9048-9088-3A233BBF8A0E}" type="datetimeFigureOut">
              <a:rPr kumimoji="1" lang="ja-JP" altLang="en-US" smtClean="0"/>
              <a:t>2020/12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08239C3-17C2-544C-B2C5-CAA28FC5B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0D44C79-5AC6-504F-9E6B-D5005CBF1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4E394-9A5B-9741-A24D-FD8C5FDA76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5207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9D8EDEF-6EF0-3E49-B383-708230685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EB536-D259-9048-9088-3A233BBF8A0E}" type="datetimeFigureOut">
              <a:rPr kumimoji="1" lang="ja-JP" altLang="en-US" smtClean="0"/>
              <a:t>2020/12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E47464C-E063-A94F-8560-117C0E47B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E64819F-E3E3-A440-A36B-DD44C0E76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4E394-9A5B-9741-A24D-FD8C5FDA76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355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F16721-1893-DA4C-883B-A0794D70CB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73A4030-CBB4-9F4B-9CBA-692EDAE8B0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F713220-CA41-6F48-9C39-9E17EF03D3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978A499-E4C9-324D-9D2E-A911A1A947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EB536-D259-9048-9088-3A233BBF8A0E}" type="datetimeFigureOut">
              <a:rPr kumimoji="1" lang="ja-JP" altLang="en-US" smtClean="0"/>
              <a:t>2020/1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2918C84-3BEA-CF4F-9041-70E739F38B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3AC4F42-D2CF-C84F-8992-E29E90579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4E394-9A5B-9741-A24D-FD8C5FDA76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5493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C5C52D7-4EEC-1046-8A79-90E4C6BE2F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537E541-C492-354C-BDDB-5C58A98D7A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38D9A8A-C771-5149-B297-77BC739EF5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25D60EC-E651-AF4E-BA83-080DD6154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EB536-D259-9048-9088-3A233BBF8A0E}" type="datetimeFigureOut">
              <a:rPr kumimoji="1" lang="ja-JP" altLang="en-US" smtClean="0"/>
              <a:t>2020/1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C0133B1-589A-084F-AB80-ADAD6AEAA3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62B522A-956D-3D43-B478-0BC064297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E4E394-9A5B-9741-A24D-FD8C5FDA76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2284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85AB239-4775-8543-8B8A-C4CA040497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EACAC7B-89AA-7846-B743-36C4191DF6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F2BDCA7-B8F8-D841-B469-41CC0B34C5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EB536-D259-9048-9088-3A233BBF8A0E}" type="datetimeFigureOut">
              <a:rPr kumimoji="1" lang="ja-JP" altLang="en-US" smtClean="0"/>
              <a:t>2020/1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93189C7-5F57-E14B-91F3-C261BC0289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1BE8818-977C-2B4A-B620-58EF215EEB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E4E394-9A5B-9741-A24D-FD8C5FDA76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1359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nishios@affrc.go.jp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mailto:nishios@affrc.go.jp" TargetMode="External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hyperlink" Target="mailto:nishios@affrc.go.jp" TargetMode="Externa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18" Type="http://schemas.openxmlformats.org/officeDocument/2006/relationships/image" Target="../media/image18.emf"/><Relationship Id="rId3" Type="http://schemas.openxmlformats.org/officeDocument/2006/relationships/image" Target="../media/image3.jpg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17" Type="http://schemas.openxmlformats.org/officeDocument/2006/relationships/image" Target="../media/image17.emf"/><Relationship Id="rId2" Type="http://schemas.openxmlformats.org/officeDocument/2006/relationships/hyperlink" Target="mailto:nishios@affrc.go.jp" TargetMode="External"/><Relationship Id="rId16" Type="http://schemas.openxmlformats.org/officeDocument/2006/relationships/image" Target="../media/image16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5" Type="http://schemas.openxmlformats.org/officeDocument/2006/relationships/image" Target="../media/image15.emf"/><Relationship Id="rId10" Type="http://schemas.openxmlformats.org/officeDocument/2006/relationships/image" Target="../media/image10.emf"/><Relationship Id="rId19" Type="http://schemas.openxmlformats.org/officeDocument/2006/relationships/hyperlink" Target="https://mapchart.net/" TargetMode="External"/><Relationship Id="rId4" Type="http://schemas.openxmlformats.org/officeDocument/2006/relationships/image" Target="../media/image4.emf"/><Relationship Id="rId9" Type="http://schemas.openxmlformats.org/officeDocument/2006/relationships/image" Target="../media/image9.emf"/><Relationship Id="rId14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549E396E-0D6D-47FC-80E2-CD83A53E8BCE}"/>
              </a:ext>
            </a:extLst>
          </p:cNvPr>
          <p:cNvSpPr/>
          <p:nvPr/>
        </p:nvSpPr>
        <p:spPr>
          <a:xfrm>
            <a:off x="390525" y="84142"/>
            <a:ext cx="11410950" cy="61903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b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information</a:t>
            </a:r>
          </a:p>
          <a:p>
            <a:pPr>
              <a:lnSpc>
                <a:spcPct val="150000"/>
              </a:lnSpc>
              <a:spcAft>
                <a:spcPts val="0"/>
              </a:spcAft>
            </a:pPr>
            <a:endParaRPr lang="en-US" altLang="ja-JP" sz="1400" b="1" kern="100" dirty="0"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b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itle:</a:t>
            </a:r>
            <a:endParaRPr lang="ja-JP" altLang="ja-JP" sz="1400" kern="10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enetic structure analysis of cultivated and wild chestnut populations reveals gene flow from cultivars to natural stands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b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: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Nishio</a:t>
            </a:r>
            <a:r>
              <a:rPr lang="en-US" altLang="ja-JP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*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Norio Takada</a:t>
            </a:r>
            <a:r>
              <a:rPr lang="en-US" altLang="ja-JP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ingo Terakami</a:t>
            </a:r>
            <a:r>
              <a:rPr lang="en-US" altLang="ja-JP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Yukie Takeuchi</a:t>
            </a:r>
            <a:r>
              <a:rPr lang="en-US" altLang="ja-JP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egumi K. Kimura</a:t>
            </a:r>
            <a:r>
              <a:rPr lang="en-US" altLang="ja-JP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eiya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soda</a:t>
            </a:r>
            <a:r>
              <a:rPr lang="en-US" altLang="ja-JP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oshihiro Saito</a:t>
            </a:r>
            <a:r>
              <a:rPr lang="en-US" altLang="ja-JP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amp; Hiroyuki Iketani</a:t>
            </a:r>
            <a:r>
              <a:rPr lang="en-US" altLang="ja-JP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b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’ addresses: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stitute of Fruit Tree and Tea Science, NARO, 2-1 Fujimoto, Tsukuba, Ibaraki, Japan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orest Tree Breeding Center, Forestry and Forest Products Research Institute, </a:t>
            </a:r>
            <a:r>
              <a:rPr lang="en-US" altLang="ja-JP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Juo-cho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Ibaraki, Japan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kern="100" baseline="300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1400" kern="1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aculty 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f Biosphere-Geosphere Science, Okayama University of Science, Okayama, Okayama, Japan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kern="100" dirty="0">
                <a:solidFill>
                  <a:srgbClr val="0000FF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b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Corresponding author: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</a:t>
            </a:r>
            <a:r>
              <a:rPr lang="en-US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ishio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stitute of Fruit Tree and Tea Science, NARO, 2-1 Fujimoto, Tsukuba, Ibaraki 305-8605, Japan; Tel: +81-88-656-9310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b="1" kern="100" dirty="0">
                <a:solidFill>
                  <a:srgbClr val="006699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  <a:hlinkClick r:id="rId2"/>
              </a:rPr>
              <a:t>nishios@affrc.go.jp</a:t>
            </a:r>
            <a:endParaRPr lang="en-US" altLang="ja-JP" sz="1400" b="1" kern="100" dirty="0">
              <a:solidFill>
                <a:srgbClr val="006699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endParaRPr lang="en-US" altLang="ja-JP" sz="1400" b="1" kern="100" dirty="0">
              <a:solidFill>
                <a:srgbClr val="006699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4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1-S3</a:t>
            </a:r>
          </a:p>
          <a:p>
            <a:pPr>
              <a:lnSpc>
                <a:spcPct val="150000"/>
              </a:lnSpc>
            </a:pPr>
            <a:r>
              <a:rPr lang="en-US" altLang="ja-JP" sz="1400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Tables S1-S10 </a:t>
            </a:r>
          </a:p>
        </p:txBody>
      </p:sp>
    </p:spTree>
    <p:extLst>
      <p:ext uri="{BB962C8B-B14F-4D97-AF65-F5344CB8AC3E}">
        <p14:creationId xmlns:p14="http://schemas.microsoft.com/office/powerpoint/2010/main" val="25737171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3E7C27F6-78DC-2F40-80D8-845136CDB55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25508" y="671600"/>
            <a:ext cx="4955695" cy="2980563"/>
          </a:xfrm>
          <a:prstGeom prst="rect">
            <a:avLst/>
          </a:prstGeom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5AD22C35-979D-6041-9AD9-4DBB997AF195}"/>
              </a:ext>
            </a:extLst>
          </p:cNvPr>
          <p:cNvSpPr/>
          <p:nvPr/>
        </p:nvSpPr>
        <p:spPr>
          <a:xfrm>
            <a:off x="3731534" y="3783574"/>
            <a:ext cx="18112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" altLang="ja-JP" b="1" dirty="0">
                <a:latin typeface="Helvetica" pitchFamily="2" charset="0"/>
              </a:rPr>
              <a:t>Wild individual</a:t>
            </a:r>
            <a:endParaRPr lang="ja-JP" altLang="en-US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052412CD-CBF1-5C46-B4C0-4919DA0A9FE1}"/>
              </a:ext>
            </a:extLst>
          </p:cNvPr>
          <p:cNvSpPr/>
          <p:nvPr/>
        </p:nvSpPr>
        <p:spPr>
          <a:xfrm>
            <a:off x="6657153" y="3790440"/>
            <a:ext cx="10951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" altLang="ja-JP" b="1" dirty="0" err="1">
                <a:latin typeface="Helvetica" pitchFamily="2" charset="0"/>
              </a:rPr>
              <a:t>Ginyose</a:t>
            </a:r>
            <a:endParaRPr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A15C491-36CB-A040-8FEB-B1B1BFC4A525}"/>
              </a:ext>
            </a:extLst>
          </p:cNvPr>
          <p:cNvSpPr txBox="1"/>
          <p:nvPr/>
        </p:nvSpPr>
        <p:spPr>
          <a:xfrm>
            <a:off x="1362012" y="4550042"/>
            <a:ext cx="100978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Supplementary Figure S1.</a:t>
            </a:r>
            <a:r>
              <a:rPr lang="en-US" altLang="ja-JP" sz="1400" dirty="0">
                <a:latin typeface="Helvetica" pitchFamily="2" charset="0"/>
              </a:rPr>
              <a:t> Nuts of a wild individual collected in Hyogo prefecture and of traditional cultivar ‘</a:t>
            </a:r>
            <a:r>
              <a:rPr lang="en-US" altLang="ja-JP" sz="1400" dirty="0" err="1">
                <a:latin typeface="Helvetica" pitchFamily="2" charset="0"/>
              </a:rPr>
              <a:t>Ginyose</a:t>
            </a:r>
            <a:r>
              <a:rPr lang="en-US" altLang="ja-JP" sz="1400" dirty="0">
                <a:latin typeface="Helvetica" pitchFamily="2" charset="0"/>
              </a:rPr>
              <a:t>’.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15B40F5-54A2-A04D-AB5E-05160B919100}"/>
              </a:ext>
            </a:extLst>
          </p:cNvPr>
          <p:cNvSpPr txBox="1"/>
          <p:nvPr/>
        </p:nvSpPr>
        <p:spPr>
          <a:xfrm>
            <a:off x="374646" y="5165229"/>
            <a:ext cx="7390036" cy="1692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itle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enetic structure analysis of cultivated and wild chestnut populations reveals gene flow from cultivars to natural stands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b="1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:</a:t>
            </a: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Nishio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*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Norio Takada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ingo Terakami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Yukie Takeuchi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egumi K. Kimura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800" kern="100" dirty="0" err="1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eiya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soda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oshihiro Saito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amp; Hiroyuki Iketani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b="1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’ addresses: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stitute of Fruit Tree and Tea Science, NARO, 2-1 Fujimoto, Tsukuba, Ibaraki, Japan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orest Tree Breeding Center, Forestry and Forest Products Research Institute, </a:t>
            </a:r>
            <a:r>
              <a:rPr lang="en-US" altLang="ja-JP" sz="800" kern="100" dirty="0" err="1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Juo-cho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Ibaraki, Japan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aculty of Biosphere-Geosphere Science, Okayama University of Science, Okayama, Okayama, Japan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kern="100" dirty="0">
                <a:solidFill>
                  <a:srgbClr val="0000FF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Corresponding author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ishio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Institute of Fruit Tree and Tea Science, NARO, 2-1 Fujimoto, Tsukuba, Ibaraki 305-8605, Japan; Tel: +81-88-656-9310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b="1" kern="100" dirty="0">
                <a:solidFill>
                  <a:srgbClr val="006699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  <a:hlinkClick r:id="rId3"/>
              </a:rPr>
              <a:t>nishios@affrc.go.jp</a:t>
            </a:r>
            <a:endParaRPr lang="en-US" altLang="ja-JP" sz="800" b="1" kern="100" dirty="0">
              <a:solidFill>
                <a:srgbClr val="006699"/>
              </a:solidFill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endParaRPr kumimoji="1" lang="ja-JP" altLang="en-US" sz="800"/>
          </a:p>
        </p:txBody>
      </p:sp>
    </p:spTree>
    <p:extLst>
      <p:ext uri="{BB962C8B-B14F-4D97-AF65-F5344CB8AC3E}">
        <p14:creationId xmlns:p14="http://schemas.microsoft.com/office/powerpoint/2010/main" val="13701374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00F6658-262B-B14F-B47F-8AA3737E1792}"/>
              </a:ext>
            </a:extLst>
          </p:cNvPr>
          <p:cNvSpPr txBox="1"/>
          <p:nvPr/>
        </p:nvSpPr>
        <p:spPr>
          <a:xfrm>
            <a:off x="419986" y="4523761"/>
            <a:ext cx="1096012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Supplementary Figure S2. Bayesian estimates of population structure based on </a:t>
            </a:r>
            <a:r>
              <a:rPr lang="en-US" altLang="ja-JP" sz="1400" b="1" dirty="0" err="1">
                <a:latin typeface="Helvetica" pitchFamily="2" charset="0"/>
              </a:rPr>
              <a:t>nSSR</a:t>
            </a:r>
            <a:r>
              <a:rPr lang="en-US" altLang="ja-JP" sz="1400" b="1" dirty="0">
                <a:latin typeface="Helvetica" pitchFamily="2" charset="0"/>
              </a:rPr>
              <a:t> data for the 3 cultivar groups and 26 wild groups from outside Kyushu. </a:t>
            </a:r>
            <a:r>
              <a:rPr lang="en-US" altLang="ja-JP" sz="1400" dirty="0">
                <a:latin typeface="Helvetica" pitchFamily="2" charset="0"/>
              </a:rPr>
              <a:t>The STRUCTURE results for K = 2, K = 3 and K = 5 for all 32 populations and for K = 2 and K = 4 for the 29 populations excluding Kyushu, analyzed without and with LOCPRIOR, are shown for comparison. 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E4CA8219-7B7B-6844-A0C9-7120BE8D14A4}"/>
              </a:ext>
            </a:extLst>
          </p:cNvPr>
          <p:cNvSpPr txBox="1"/>
          <p:nvPr/>
        </p:nvSpPr>
        <p:spPr>
          <a:xfrm>
            <a:off x="419986" y="5174702"/>
            <a:ext cx="8375883" cy="13671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itle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enetic structure analysis of cultivated and wild chestnut populations reveals gene flow from cultivars to natural stands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b="1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:</a:t>
            </a: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Nishio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*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Norio Takada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ingo Terakami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Yukie Takeuchi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egumi K. Kimura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800" kern="100" dirty="0" err="1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eiya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soda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oshihiro Saito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amp; Hiroyuki Iketani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b="1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’ addresses: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stitute of Fruit Tree and Tea Science, NARO, 2-1 Fujimoto, Tsukuba, Ibaraki, Japan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orest Tree Breeding Center, Forestry and Forest Products Research Institute, </a:t>
            </a:r>
            <a:r>
              <a:rPr lang="en-US" altLang="ja-JP" sz="800" kern="100" dirty="0" err="1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Juo-cho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Ibaraki, Japan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aculty of Biosphere-Geosphere Science, Okayama University of Science, Okayama, Okayama, Japan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kern="100" dirty="0">
                <a:solidFill>
                  <a:srgbClr val="0000FF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Corresponding author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ishio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Institute of Fruit Tree and Tea Science, NARO, 2-1 Fujimoto, Tsukuba, Ibaraki 305-8605, Japan; Tel: +81-88-656-9310 </a:t>
            </a:r>
            <a:r>
              <a:rPr lang="en-US" altLang="ja-JP" sz="800" b="1" kern="100" dirty="0">
                <a:solidFill>
                  <a:srgbClr val="006699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  <a:hlinkClick r:id="rId2"/>
              </a:rPr>
              <a:t>nishios@affrc.go.jp</a:t>
            </a:r>
            <a:endParaRPr lang="en-US" altLang="ja-JP" sz="800" b="1" kern="100" dirty="0">
              <a:solidFill>
                <a:srgbClr val="006699"/>
              </a:solidFill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4" name="図 3" descr="グラフ&#10;&#10;自動的に生成された説明">
            <a:extLst>
              <a:ext uri="{FF2B5EF4-FFF2-40B4-BE49-F238E27FC236}">
                <a16:creationId xmlns:a16="http://schemas.microsoft.com/office/drawing/2014/main" id="{F195F4C5-2E7B-5643-ADFF-71DF7FE9AC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7446" y="713603"/>
            <a:ext cx="11125200" cy="3771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76508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DDA88B2-37C6-D142-95CC-37AFB8BB71AA}"/>
              </a:ext>
            </a:extLst>
          </p:cNvPr>
          <p:cNvSpPr txBox="1"/>
          <p:nvPr/>
        </p:nvSpPr>
        <p:spPr>
          <a:xfrm>
            <a:off x="298000" y="5469462"/>
            <a:ext cx="8375883" cy="13671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itle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enetic structure analysis of cultivated and wild chestnut populations reveals gene flow from cultivars to natural stands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b="1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:</a:t>
            </a: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Nishio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*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Norio Takada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hingo Terakami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Yukie Takeuchi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egumi K. Kimura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800" kern="100" dirty="0" err="1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eiya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soda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oshihiro Saito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amp; Hiroyuki Iketani</a:t>
            </a: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b="1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uthors’ addresses: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stitute of Fruit Tree and Tea Science, NARO, 2-1 Fujimoto, Tsukuba, Ibaraki, Japan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orest Tree Breeding Center, Forestry and Forest Products Research Institute, </a:t>
            </a:r>
            <a:r>
              <a:rPr lang="en-US" altLang="ja-JP" sz="800" kern="100" dirty="0" err="1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Juo-cho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Ibaraki, Japan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kern="100" baseline="300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800" kern="100" dirty="0">
                <a:solidFill>
                  <a:srgbClr val="000000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aculty of Biosphere-Geosphere Science, Okayama University of Science, Okayama, Okayama, Japan</a:t>
            </a:r>
            <a:endParaRPr lang="ja-JP" altLang="ja-JP" sz="800" kern="100"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800" kern="100" dirty="0">
                <a:solidFill>
                  <a:srgbClr val="0000FF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r>
              <a:rPr lang="en-US" altLang="ja-JP" sz="800" b="1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Corresponding author: 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go </a:t>
            </a:r>
            <a:r>
              <a:rPr lang="en-US" altLang="ja-JP" sz="800" kern="100" dirty="0" err="1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ishio</a:t>
            </a:r>
            <a:r>
              <a:rPr lang="en-US" altLang="ja-JP" sz="800" kern="100" dirty="0"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Institute of Fruit Tree and Tea Science, NARO, 2-1 Fujimoto, Tsukuba, Ibaraki 305-8605, Japan; Tel: +81-88-656-9310 </a:t>
            </a:r>
            <a:r>
              <a:rPr lang="en-US" altLang="ja-JP" sz="800" b="1" kern="100" dirty="0">
                <a:solidFill>
                  <a:srgbClr val="006699"/>
                </a:solidFill>
                <a:latin typeface="Helvetica" pitchFamily="2" charset="0"/>
                <a:ea typeface="ＭＳ 明朝" panose="02020609040205080304" pitchFamily="17" charset="-128"/>
                <a:cs typeface="Times New Roman" panose="02020603050405020304" pitchFamily="18" charset="0"/>
                <a:hlinkClick r:id="rId2"/>
              </a:rPr>
              <a:t>nishios@affrc.go.jp</a:t>
            </a:r>
            <a:endParaRPr lang="en-US" altLang="ja-JP" sz="800" b="1" kern="100" dirty="0">
              <a:solidFill>
                <a:srgbClr val="006699"/>
              </a:solidFill>
              <a:latin typeface="Helvetica" pitchFamily="2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D58E38B4-1B81-F549-8F02-71360A1D1E00}"/>
              </a:ext>
            </a:extLst>
          </p:cNvPr>
          <p:cNvGrpSpPr/>
          <p:nvPr/>
        </p:nvGrpSpPr>
        <p:grpSpPr>
          <a:xfrm>
            <a:off x="347869" y="-9939"/>
            <a:ext cx="10479540" cy="4358849"/>
            <a:chOff x="347869" y="0"/>
            <a:chExt cx="10479540" cy="4358849"/>
          </a:xfrm>
        </p:grpSpPr>
        <p:pic>
          <p:nvPicPr>
            <p:cNvPr id="12" name="図 11" descr="ダイアグラム が含まれている画像&#10;&#10;自動的に生成された説明">
              <a:extLst>
                <a:ext uri="{FF2B5EF4-FFF2-40B4-BE49-F238E27FC236}">
                  <a16:creationId xmlns:a16="http://schemas.microsoft.com/office/drawing/2014/main" id="{E6DAAA2E-91D1-4A42-ABD5-DA96ECD7A8E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74498" y="0"/>
              <a:ext cx="4352911" cy="4358849"/>
            </a:xfrm>
            <a:prstGeom prst="rect">
              <a:avLst/>
            </a:prstGeom>
          </p:spPr>
        </p:pic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46B54DF7-B2BA-8440-9491-7503E1017680}"/>
                </a:ext>
              </a:extLst>
            </p:cNvPr>
            <p:cNvGrpSpPr/>
            <p:nvPr/>
          </p:nvGrpSpPr>
          <p:grpSpPr>
            <a:xfrm>
              <a:off x="6705429" y="30775"/>
              <a:ext cx="3767326" cy="3676633"/>
              <a:chOff x="1614288" y="1550346"/>
              <a:chExt cx="3767326" cy="3676633"/>
            </a:xfrm>
          </p:grpSpPr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7E14362C-B4FB-9240-894A-BEBFE4713FDD}"/>
                  </a:ext>
                </a:extLst>
              </p:cNvPr>
              <p:cNvSpPr txBox="1"/>
              <p:nvPr/>
            </p:nvSpPr>
            <p:spPr>
              <a:xfrm>
                <a:off x="1742143" y="1550346"/>
                <a:ext cx="2418775" cy="42881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kumimoji="1" lang="ja-JP" altLang="en-US" dirty="0"/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8C3AE8B9-1FD1-DF42-9CF9-5C37C1B9E204}"/>
                  </a:ext>
                </a:extLst>
              </p:cNvPr>
              <p:cNvSpPr txBox="1"/>
              <p:nvPr/>
            </p:nvSpPr>
            <p:spPr>
              <a:xfrm>
                <a:off x="4863736" y="3093747"/>
                <a:ext cx="503434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 anchor="ctr" anchorCtr="1">
                <a:spAutoFit/>
              </a:bodyPr>
              <a:lstStyle/>
              <a:p>
                <a:r>
                  <a:rPr kumimoji="1" lang="en-US" altLang="ja-JP" sz="1000" dirty="0">
                    <a:latin typeface="Helvetica" pitchFamily="2" charset="0"/>
                  </a:rPr>
                  <a:t>Aomori</a:t>
                </a:r>
              </a:p>
            </p:txBody>
          </p:sp>
          <p:cxnSp>
            <p:nvCxnSpPr>
              <p:cNvPr id="16" name="直線矢印コネクタ 15">
                <a:extLst>
                  <a:ext uri="{FF2B5EF4-FFF2-40B4-BE49-F238E27FC236}">
                    <a16:creationId xmlns:a16="http://schemas.microsoft.com/office/drawing/2014/main" id="{005B747D-6E20-F74B-A399-4159101BF409}"/>
                  </a:ext>
                </a:extLst>
              </p:cNvPr>
              <p:cNvCxnSpPr/>
              <p:nvPr/>
            </p:nvCxnSpPr>
            <p:spPr>
              <a:xfrm flipH="1">
                <a:off x="4598158" y="3081848"/>
                <a:ext cx="246580" cy="72099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線矢印コネクタ 16">
                <a:extLst>
                  <a:ext uri="{FF2B5EF4-FFF2-40B4-BE49-F238E27FC236}">
                    <a16:creationId xmlns:a16="http://schemas.microsoft.com/office/drawing/2014/main" id="{74135E94-EBA6-7A4E-8225-48CC05546B6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522511" y="3661143"/>
                <a:ext cx="333361" cy="8671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8F05327E-7410-D04F-924C-16848D8A8186}"/>
                  </a:ext>
                </a:extLst>
              </p:cNvPr>
              <p:cNvSpPr txBox="1"/>
              <p:nvPr/>
            </p:nvSpPr>
            <p:spPr>
              <a:xfrm>
                <a:off x="4847925" y="3718782"/>
                <a:ext cx="503434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 anchor="ctr" anchorCtr="1">
                <a:spAutoFit/>
              </a:bodyPr>
              <a:lstStyle/>
              <a:p>
                <a:r>
                  <a:rPr kumimoji="1" lang="en-US" altLang="ja-JP" sz="1000" dirty="0">
                    <a:latin typeface="Helvetica" pitchFamily="2" charset="0"/>
                  </a:rPr>
                  <a:t>Miyagi</a:t>
                </a:r>
              </a:p>
            </p:txBody>
          </p:sp>
          <p:cxnSp>
            <p:nvCxnSpPr>
              <p:cNvPr id="19" name="直線矢印コネクタ 18">
                <a:extLst>
                  <a:ext uri="{FF2B5EF4-FFF2-40B4-BE49-F238E27FC236}">
                    <a16:creationId xmlns:a16="http://schemas.microsoft.com/office/drawing/2014/main" id="{83C1538E-FC93-7247-B4CF-0333DB7461A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80872" y="3783341"/>
                <a:ext cx="184265" cy="523256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5881BF1F-D9CA-FA4A-B25E-9508EEB07E40}"/>
                  </a:ext>
                </a:extLst>
              </p:cNvPr>
              <p:cNvSpPr txBox="1"/>
              <p:nvPr/>
            </p:nvSpPr>
            <p:spPr>
              <a:xfrm>
                <a:off x="3709894" y="3609931"/>
                <a:ext cx="503434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 anchor="ctr" anchorCtr="1">
                <a:spAutoFit/>
              </a:bodyPr>
              <a:lstStyle/>
              <a:p>
                <a:r>
                  <a:rPr kumimoji="1" lang="en-US" altLang="ja-JP" sz="1000" dirty="0">
                    <a:latin typeface="Helvetica" pitchFamily="2" charset="0"/>
                  </a:rPr>
                  <a:t>Tochigi</a:t>
                </a:r>
              </a:p>
            </p:txBody>
          </p:sp>
          <p:cxnSp>
            <p:nvCxnSpPr>
              <p:cNvPr id="21" name="直線矢印コネクタ 20">
                <a:extLst>
                  <a:ext uri="{FF2B5EF4-FFF2-40B4-BE49-F238E27FC236}">
                    <a16:creationId xmlns:a16="http://schemas.microsoft.com/office/drawing/2014/main" id="{A111C490-15C1-3A49-9B3A-1582051C1BE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90185" y="4287332"/>
                <a:ext cx="465687" cy="64327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B0010BFF-6934-6048-8918-5D20DC5A3CEC}"/>
                  </a:ext>
                </a:extLst>
              </p:cNvPr>
              <p:cNvSpPr txBox="1"/>
              <p:nvPr/>
            </p:nvSpPr>
            <p:spPr>
              <a:xfrm>
                <a:off x="4878180" y="4343751"/>
                <a:ext cx="503434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 anchor="ctr" anchorCtr="1">
                <a:spAutoFit/>
              </a:bodyPr>
              <a:lstStyle/>
              <a:p>
                <a:r>
                  <a:rPr kumimoji="1" lang="en-US" altLang="ja-JP" sz="1000" dirty="0">
                    <a:latin typeface="Helvetica" pitchFamily="2" charset="0"/>
                  </a:rPr>
                  <a:t>Ibaraki</a:t>
                </a:r>
              </a:p>
            </p:txBody>
          </p:sp>
          <p:cxnSp>
            <p:nvCxnSpPr>
              <p:cNvPr id="23" name="直線矢印コネクタ 22">
                <a:extLst>
                  <a:ext uri="{FF2B5EF4-FFF2-40B4-BE49-F238E27FC236}">
                    <a16:creationId xmlns:a16="http://schemas.microsoft.com/office/drawing/2014/main" id="{C6E821C8-8B50-0D4D-806C-0148B638890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232956" y="4269096"/>
                <a:ext cx="375199" cy="500769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A9897417-3215-5649-80CA-92EBCE2F0A4C}"/>
                  </a:ext>
                </a:extLst>
              </p:cNvPr>
              <p:cNvSpPr txBox="1"/>
              <p:nvPr/>
            </p:nvSpPr>
            <p:spPr>
              <a:xfrm>
                <a:off x="4549521" y="5073091"/>
                <a:ext cx="503434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 anchor="ctr" anchorCtr="1">
                <a:spAutoFit/>
              </a:bodyPr>
              <a:lstStyle/>
              <a:p>
                <a:r>
                  <a:rPr kumimoji="1" lang="en-US" altLang="ja-JP" sz="1000" dirty="0">
                    <a:latin typeface="Helvetica" pitchFamily="2" charset="0"/>
                  </a:rPr>
                  <a:t>Gunma</a:t>
                </a:r>
              </a:p>
            </p:txBody>
          </p:sp>
          <p:cxnSp>
            <p:nvCxnSpPr>
              <p:cNvPr id="25" name="直線矢印コネクタ 24">
                <a:extLst>
                  <a:ext uri="{FF2B5EF4-FFF2-40B4-BE49-F238E27FC236}">
                    <a16:creationId xmlns:a16="http://schemas.microsoft.com/office/drawing/2014/main" id="{E7179DE3-850C-AC47-B739-A690FB3CB9F5}"/>
                  </a:ext>
                </a:extLst>
              </p:cNvPr>
              <p:cNvCxnSpPr>
                <a:cxnSpLocks/>
                <a:stCxn id="26" idx="2"/>
              </p:cNvCxnSpPr>
              <p:nvPr/>
            </p:nvCxnSpPr>
            <p:spPr>
              <a:xfrm>
                <a:off x="3471926" y="3783341"/>
                <a:ext cx="430999" cy="653777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67282D0B-05A9-B348-98FA-9BE2EA17D179}"/>
                  </a:ext>
                </a:extLst>
              </p:cNvPr>
              <p:cNvSpPr txBox="1"/>
              <p:nvPr/>
            </p:nvSpPr>
            <p:spPr>
              <a:xfrm>
                <a:off x="3220209" y="3629453"/>
                <a:ext cx="503434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 anchor="ctr" anchorCtr="1">
                <a:spAutoFit/>
              </a:bodyPr>
              <a:lstStyle/>
              <a:p>
                <a:r>
                  <a:rPr kumimoji="1" lang="en-US" altLang="ja-JP" sz="1000" dirty="0">
                    <a:latin typeface="Helvetica" pitchFamily="2" charset="0"/>
                  </a:rPr>
                  <a:t>Nagano</a:t>
                </a:r>
              </a:p>
            </p:txBody>
          </p:sp>
          <p:cxnSp>
            <p:nvCxnSpPr>
              <p:cNvPr id="27" name="直線矢印コネクタ 26">
                <a:extLst>
                  <a:ext uri="{FF2B5EF4-FFF2-40B4-BE49-F238E27FC236}">
                    <a16:creationId xmlns:a16="http://schemas.microsoft.com/office/drawing/2014/main" id="{DAC4C2B8-3CD5-144D-8B1D-B3A34A1C9B2D}"/>
                  </a:ext>
                </a:extLst>
              </p:cNvPr>
              <p:cNvCxnSpPr>
                <a:cxnSpLocks/>
                <a:stCxn id="28" idx="2"/>
              </p:cNvCxnSpPr>
              <p:nvPr/>
            </p:nvCxnSpPr>
            <p:spPr>
              <a:xfrm flipH="1">
                <a:off x="2923034" y="4285138"/>
                <a:ext cx="369094" cy="500325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F4736D2A-64D7-BF4B-BCC6-F494537D9754}"/>
                  </a:ext>
                </a:extLst>
              </p:cNvPr>
              <p:cNvSpPr txBox="1"/>
              <p:nvPr/>
            </p:nvSpPr>
            <p:spPr>
              <a:xfrm>
                <a:off x="3001513" y="4131250"/>
                <a:ext cx="581229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 anchor="ctr" anchorCtr="1">
                <a:spAutoFit/>
              </a:bodyPr>
              <a:lstStyle/>
              <a:p>
                <a:r>
                  <a:rPr kumimoji="1" lang="en-US" altLang="ja-JP" sz="1000" dirty="0">
                    <a:latin typeface="Helvetica" pitchFamily="2" charset="0"/>
                  </a:rPr>
                  <a:t>Okayama</a:t>
                </a: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686EA81A-988E-5944-8E3D-EC188E3EB0E9}"/>
                  </a:ext>
                </a:extLst>
              </p:cNvPr>
              <p:cNvSpPr txBox="1"/>
              <p:nvPr/>
            </p:nvSpPr>
            <p:spPr>
              <a:xfrm>
                <a:off x="2341805" y="4005601"/>
                <a:ext cx="581229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 anchor="ctr" anchorCtr="1">
                <a:spAutoFit/>
              </a:bodyPr>
              <a:lstStyle/>
              <a:p>
                <a:r>
                  <a:rPr kumimoji="1" lang="en-US" altLang="ja-JP" sz="1000" dirty="0">
                    <a:latin typeface="Helvetica" pitchFamily="2" charset="0"/>
                  </a:rPr>
                  <a:t>Tottori</a:t>
                </a:r>
              </a:p>
            </p:txBody>
          </p:sp>
          <p:cxnSp>
            <p:nvCxnSpPr>
              <p:cNvPr id="30" name="直線矢印コネクタ 29">
                <a:extLst>
                  <a:ext uri="{FF2B5EF4-FFF2-40B4-BE49-F238E27FC236}">
                    <a16:creationId xmlns:a16="http://schemas.microsoft.com/office/drawing/2014/main" id="{0DB15452-B217-9849-AEB0-403C7121CF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51662" y="4147298"/>
                <a:ext cx="262353" cy="459954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F5637EE5-B310-074C-9943-5F875F24A51D}"/>
                  </a:ext>
                </a:extLst>
              </p:cNvPr>
              <p:cNvSpPr txBox="1"/>
              <p:nvPr/>
            </p:nvSpPr>
            <p:spPr>
              <a:xfrm>
                <a:off x="2051190" y="4340492"/>
                <a:ext cx="581229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 anchor="ctr" anchorCtr="1">
                <a:spAutoFit/>
              </a:bodyPr>
              <a:lstStyle/>
              <a:p>
                <a:r>
                  <a:rPr kumimoji="1" lang="en-US" altLang="ja-JP" sz="1000" dirty="0">
                    <a:latin typeface="Helvetica" pitchFamily="2" charset="0"/>
                  </a:rPr>
                  <a:t>Shimane</a:t>
                </a:r>
              </a:p>
            </p:txBody>
          </p:sp>
          <p:cxnSp>
            <p:nvCxnSpPr>
              <p:cNvPr id="32" name="直線矢印コネクタ 31">
                <a:extLst>
                  <a:ext uri="{FF2B5EF4-FFF2-40B4-BE49-F238E27FC236}">
                    <a16:creationId xmlns:a16="http://schemas.microsoft.com/office/drawing/2014/main" id="{F1C61566-38E4-0548-9D93-D6CAF6F43282}"/>
                  </a:ext>
                </a:extLst>
              </p:cNvPr>
              <p:cNvCxnSpPr>
                <a:cxnSpLocks/>
                <a:stCxn id="31" idx="2"/>
              </p:cNvCxnSpPr>
              <p:nvPr/>
            </p:nvCxnSpPr>
            <p:spPr>
              <a:xfrm>
                <a:off x="2341805" y="4494380"/>
                <a:ext cx="200770" cy="23336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線矢印コネクタ 32">
                <a:extLst>
                  <a:ext uri="{FF2B5EF4-FFF2-40B4-BE49-F238E27FC236}">
                    <a16:creationId xmlns:a16="http://schemas.microsoft.com/office/drawing/2014/main" id="{7491760B-CCB9-F24B-BE2B-DE5FF331C8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05734" y="4705991"/>
                <a:ext cx="200770" cy="23336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AFCA62B3-8802-664A-B296-E520640188A2}"/>
                  </a:ext>
                </a:extLst>
              </p:cNvPr>
              <p:cNvSpPr txBox="1"/>
              <p:nvPr/>
            </p:nvSpPr>
            <p:spPr>
              <a:xfrm>
                <a:off x="1614288" y="4534116"/>
                <a:ext cx="658535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 anchor="ctr" anchorCtr="1">
                <a:spAutoFit/>
              </a:bodyPr>
              <a:lstStyle/>
              <a:p>
                <a:r>
                  <a:rPr kumimoji="1" lang="en-US" altLang="ja-JP" sz="1000" dirty="0">
                    <a:latin typeface="Helvetica" pitchFamily="2" charset="0"/>
                  </a:rPr>
                  <a:t>Ya</a:t>
                </a:r>
                <a:r>
                  <a:rPr lang="en-US" altLang="ja-JP" sz="1000" dirty="0">
                    <a:latin typeface="Helvetica" pitchFamily="2" charset="0"/>
                  </a:rPr>
                  <a:t>maguchi</a:t>
                </a:r>
                <a:endParaRPr kumimoji="1" lang="en-US" altLang="ja-JP" sz="1000" dirty="0">
                  <a:latin typeface="Helvetica" pitchFamily="2" charset="0"/>
                </a:endParaRPr>
              </a:p>
            </p:txBody>
          </p:sp>
        </p:grpSp>
        <p:cxnSp>
          <p:nvCxnSpPr>
            <p:cNvPr id="35" name="直線矢印コネクタ 34">
              <a:extLst>
                <a:ext uri="{FF2B5EF4-FFF2-40B4-BE49-F238E27FC236}">
                  <a16:creationId xmlns:a16="http://schemas.microsoft.com/office/drawing/2014/main" id="{10B66133-4A00-CF45-81E0-99235E860CA7}"/>
                </a:ext>
              </a:extLst>
            </p:cNvPr>
            <p:cNvCxnSpPr>
              <a:cxnSpLocks/>
            </p:cNvCxnSpPr>
            <p:nvPr/>
          </p:nvCxnSpPr>
          <p:spPr>
            <a:xfrm>
              <a:off x="9223257" y="1640970"/>
              <a:ext cx="258069" cy="26664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51A2AD1F-F660-B54A-A420-7A5B2F5709A2}"/>
                </a:ext>
              </a:extLst>
            </p:cNvPr>
            <p:cNvSpPr txBox="1"/>
            <p:nvPr/>
          </p:nvSpPr>
          <p:spPr>
            <a:xfrm>
              <a:off x="8867774" y="1467793"/>
              <a:ext cx="503434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Akita</a:t>
              </a:r>
            </a:p>
          </p:txBody>
        </p:sp>
        <p:pic>
          <p:nvPicPr>
            <p:cNvPr id="37" name="図 36">
              <a:extLst>
                <a:ext uri="{FF2B5EF4-FFF2-40B4-BE49-F238E27FC236}">
                  <a16:creationId xmlns:a16="http://schemas.microsoft.com/office/drawing/2014/main" id="{770CA2DB-230E-EB41-8387-FE74C9B9C90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64018" y="1648088"/>
              <a:ext cx="4901855" cy="475476"/>
            </a:xfrm>
            <a:prstGeom prst="rect">
              <a:avLst/>
            </a:prstGeom>
          </p:spPr>
        </p:pic>
        <p:pic>
          <p:nvPicPr>
            <p:cNvPr id="38" name="図 37">
              <a:extLst>
                <a:ext uri="{FF2B5EF4-FFF2-40B4-BE49-F238E27FC236}">
                  <a16:creationId xmlns:a16="http://schemas.microsoft.com/office/drawing/2014/main" id="{42D86B6B-70B9-E745-B90A-92882778F1D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62592" y="2208095"/>
              <a:ext cx="4901854" cy="439593"/>
            </a:xfrm>
            <a:prstGeom prst="rect">
              <a:avLst/>
            </a:prstGeom>
          </p:spPr>
        </p:pic>
        <p:pic>
          <p:nvPicPr>
            <p:cNvPr id="39" name="図 38">
              <a:extLst>
                <a:ext uri="{FF2B5EF4-FFF2-40B4-BE49-F238E27FC236}">
                  <a16:creationId xmlns:a16="http://schemas.microsoft.com/office/drawing/2014/main" id="{280F8C9B-0115-C144-B316-2182586114E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62592" y="2731532"/>
              <a:ext cx="4901853" cy="439593"/>
            </a:xfrm>
            <a:prstGeom prst="rect">
              <a:avLst/>
            </a:prstGeom>
          </p:spPr>
        </p:pic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1098512B-1DBD-7748-A9BE-112F98956A16}"/>
                </a:ext>
              </a:extLst>
            </p:cNvPr>
            <p:cNvSpPr txBox="1"/>
            <p:nvPr/>
          </p:nvSpPr>
          <p:spPr>
            <a:xfrm>
              <a:off x="532006" y="1779163"/>
              <a:ext cx="46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Helvetica" pitchFamily="2" charset="0"/>
                </a:rPr>
                <a:t>K=2</a:t>
              </a:r>
              <a:endParaRPr kumimoji="1" lang="ja-JP" altLang="en-US" sz="1200">
                <a:latin typeface="Helvetica" pitchFamily="2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22BE8C4A-A7E5-5545-A228-F9EA5A75C90E}"/>
                </a:ext>
              </a:extLst>
            </p:cNvPr>
            <p:cNvSpPr txBox="1"/>
            <p:nvPr/>
          </p:nvSpPr>
          <p:spPr>
            <a:xfrm>
              <a:off x="529254" y="2291714"/>
              <a:ext cx="46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Helvetica" pitchFamily="2" charset="0"/>
                </a:rPr>
                <a:t>K=3</a:t>
              </a:r>
              <a:endParaRPr kumimoji="1" lang="ja-JP" altLang="en-US" sz="1200">
                <a:latin typeface="Helvetica" pitchFamily="2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991E1C11-053D-CC4C-AABB-BE96BCF7B2B6}"/>
                </a:ext>
              </a:extLst>
            </p:cNvPr>
            <p:cNvSpPr txBox="1"/>
            <p:nvPr/>
          </p:nvSpPr>
          <p:spPr>
            <a:xfrm>
              <a:off x="532006" y="2806902"/>
              <a:ext cx="4619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Helvetica" pitchFamily="2" charset="0"/>
                </a:rPr>
                <a:t>K=5</a:t>
              </a:r>
              <a:endParaRPr kumimoji="1" lang="ja-JP" altLang="en-US" sz="1200">
                <a:latin typeface="Helvetica" pitchFamily="2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01EDD38C-A3DA-5447-A5CB-7688B7839931}"/>
                </a:ext>
              </a:extLst>
            </p:cNvPr>
            <p:cNvSpPr txBox="1"/>
            <p:nvPr/>
          </p:nvSpPr>
          <p:spPr>
            <a:xfrm>
              <a:off x="2728382" y="1409666"/>
              <a:ext cx="15520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Helvetica" pitchFamily="2" charset="0"/>
                </a:rPr>
                <a:t>Without LOCPRIOR</a:t>
              </a:r>
              <a:endParaRPr kumimoji="1" lang="ja-JP" altLang="en-US" sz="1200">
                <a:latin typeface="Helvetica" pitchFamily="2" charset="0"/>
              </a:endParaRPr>
            </a:p>
          </p:txBody>
        </p: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9B8F0BE7-2703-8247-AD5A-2FD1169A1C06}"/>
                </a:ext>
              </a:extLst>
            </p:cNvPr>
            <p:cNvCxnSpPr>
              <a:cxnSpLocks/>
            </p:cNvCxnSpPr>
            <p:nvPr/>
          </p:nvCxnSpPr>
          <p:spPr>
            <a:xfrm>
              <a:off x="963967" y="3170993"/>
              <a:ext cx="0" cy="1356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C37ED1E2-7A2B-0D42-96DB-057052527FA5}"/>
                </a:ext>
              </a:extLst>
            </p:cNvPr>
            <p:cNvCxnSpPr>
              <a:cxnSpLocks/>
            </p:cNvCxnSpPr>
            <p:nvPr/>
          </p:nvCxnSpPr>
          <p:spPr>
            <a:xfrm>
              <a:off x="1403446" y="3170993"/>
              <a:ext cx="0" cy="1356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194F59C8-DF03-C346-9686-58B87D755FF6}"/>
                </a:ext>
              </a:extLst>
            </p:cNvPr>
            <p:cNvCxnSpPr>
              <a:cxnSpLocks/>
            </p:cNvCxnSpPr>
            <p:nvPr/>
          </p:nvCxnSpPr>
          <p:spPr>
            <a:xfrm>
              <a:off x="1555846" y="3170993"/>
              <a:ext cx="0" cy="1356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33092343-D357-304F-B2F6-9E255E3A24F8}"/>
                </a:ext>
              </a:extLst>
            </p:cNvPr>
            <p:cNvCxnSpPr>
              <a:cxnSpLocks/>
            </p:cNvCxnSpPr>
            <p:nvPr/>
          </p:nvCxnSpPr>
          <p:spPr>
            <a:xfrm>
              <a:off x="2021907" y="3170993"/>
              <a:ext cx="0" cy="1356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B6954AE8-AD8F-B744-977C-D263D6A845FA}"/>
                </a:ext>
              </a:extLst>
            </p:cNvPr>
            <p:cNvCxnSpPr>
              <a:cxnSpLocks/>
            </p:cNvCxnSpPr>
            <p:nvPr/>
          </p:nvCxnSpPr>
          <p:spPr>
            <a:xfrm>
              <a:off x="2440121" y="3170993"/>
              <a:ext cx="0" cy="1356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67B4CF1F-8110-3F4E-9A75-B0CABB24F20A}"/>
                </a:ext>
              </a:extLst>
            </p:cNvPr>
            <p:cNvCxnSpPr>
              <a:cxnSpLocks/>
            </p:cNvCxnSpPr>
            <p:nvPr/>
          </p:nvCxnSpPr>
          <p:spPr>
            <a:xfrm>
              <a:off x="2799856" y="3170993"/>
              <a:ext cx="0" cy="1356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21CF7281-3F91-CD4E-96C5-4B084111AC96}"/>
                </a:ext>
              </a:extLst>
            </p:cNvPr>
            <p:cNvCxnSpPr>
              <a:cxnSpLocks/>
            </p:cNvCxnSpPr>
            <p:nvPr/>
          </p:nvCxnSpPr>
          <p:spPr>
            <a:xfrm>
              <a:off x="3117060" y="3170993"/>
              <a:ext cx="0" cy="1356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D6468FD7-B7AA-4847-BB67-9DFC2D9BCF8B}"/>
                </a:ext>
              </a:extLst>
            </p:cNvPr>
            <p:cNvCxnSpPr>
              <a:cxnSpLocks/>
            </p:cNvCxnSpPr>
            <p:nvPr/>
          </p:nvCxnSpPr>
          <p:spPr>
            <a:xfrm>
              <a:off x="3684130" y="3170993"/>
              <a:ext cx="0" cy="1356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02DD9469-902E-EA4F-8AD9-BCB9678D5BAC}"/>
                </a:ext>
              </a:extLst>
            </p:cNvPr>
            <p:cNvCxnSpPr>
              <a:cxnSpLocks/>
            </p:cNvCxnSpPr>
            <p:nvPr/>
          </p:nvCxnSpPr>
          <p:spPr>
            <a:xfrm>
              <a:off x="3996018" y="3170993"/>
              <a:ext cx="0" cy="1356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42CDBCC4-1651-194D-925F-F541EFFA12C2}"/>
                </a:ext>
              </a:extLst>
            </p:cNvPr>
            <p:cNvCxnSpPr>
              <a:cxnSpLocks/>
            </p:cNvCxnSpPr>
            <p:nvPr/>
          </p:nvCxnSpPr>
          <p:spPr>
            <a:xfrm>
              <a:off x="4775739" y="3170993"/>
              <a:ext cx="0" cy="1356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353E77E7-B2E5-A94E-81F1-21F3B71F0C61}"/>
                </a:ext>
              </a:extLst>
            </p:cNvPr>
            <p:cNvCxnSpPr>
              <a:cxnSpLocks/>
            </p:cNvCxnSpPr>
            <p:nvPr/>
          </p:nvCxnSpPr>
          <p:spPr>
            <a:xfrm>
              <a:off x="5720265" y="3170993"/>
              <a:ext cx="0" cy="1356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3698DF80-CB85-B442-8A22-02969786EB1B}"/>
                </a:ext>
              </a:extLst>
            </p:cNvPr>
            <p:cNvCxnSpPr>
              <a:cxnSpLocks/>
            </p:cNvCxnSpPr>
            <p:nvPr/>
          </p:nvCxnSpPr>
          <p:spPr>
            <a:xfrm>
              <a:off x="5202813" y="3170993"/>
              <a:ext cx="0" cy="1356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D69F3E0D-2793-3649-8B55-88E5ED859F0D}"/>
                </a:ext>
              </a:extLst>
            </p:cNvPr>
            <p:cNvSpPr txBox="1"/>
            <p:nvPr/>
          </p:nvSpPr>
          <p:spPr>
            <a:xfrm>
              <a:off x="949582" y="3329625"/>
              <a:ext cx="503434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Aomori</a:t>
              </a: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587C3D5E-C68F-2746-8D89-B2930E618296}"/>
                </a:ext>
              </a:extLst>
            </p:cNvPr>
            <p:cNvSpPr txBox="1"/>
            <p:nvPr/>
          </p:nvSpPr>
          <p:spPr>
            <a:xfrm>
              <a:off x="1240122" y="3477026"/>
              <a:ext cx="503434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Miyagi</a:t>
              </a: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21561CB7-2271-BF45-B344-5417D3A80A3F}"/>
                </a:ext>
              </a:extLst>
            </p:cNvPr>
            <p:cNvSpPr txBox="1"/>
            <p:nvPr/>
          </p:nvSpPr>
          <p:spPr>
            <a:xfrm>
              <a:off x="1518473" y="3325836"/>
              <a:ext cx="503434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Akita</a:t>
              </a: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81662499-EF62-5E4A-851D-5DC55241BB9D}"/>
                </a:ext>
              </a:extLst>
            </p:cNvPr>
            <p:cNvSpPr txBox="1"/>
            <p:nvPr/>
          </p:nvSpPr>
          <p:spPr>
            <a:xfrm>
              <a:off x="1985820" y="3325836"/>
              <a:ext cx="503434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Tochigi</a:t>
              </a: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B815E401-4417-414E-959F-79078C7750E9}"/>
                </a:ext>
              </a:extLst>
            </p:cNvPr>
            <p:cNvSpPr txBox="1"/>
            <p:nvPr/>
          </p:nvSpPr>
          <p:spPr>
            <a:xfrm>
              <a:off x="2375058" y="3477026"/>
              <a:ext cx="503434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Ibaraki</a:t>
              </a: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564E8416-61F7-3941-A272-A630EABA7631}"/>
                </a:ext>
              </a:extLst>
            </p:cNvPr>
            <p:cNvSpPr txBox="1"/>
            <p:nvPr/>
          </p:nvSpPr>
          <p:spPr>
            <a:xfrm>
              <a:off x="2728209" y="3326405"/>
              <a:ext cx="503434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Gunma</a:t>
              </a: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A1C78810-B450-F340-81AB-3178D813D81C}"/>
                </a:ext>
              </a:extLst>
            </p:cNvPr>
            <p:cNvSpPr txBox="1"/>
            <p:nvPr/>
          </p:nvSpPr>
          <p:spPr>
            <a:xfrm>
              <a:off x="3155489" y="3477026"/>
              <a:ext cx="503434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Nagano</a:t>
              </a: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1A747ED4-4F0D-1D49-880E-3D365CC9E7E9}"/>
                </a:ext>
              </a:extLst>
            </p:cNvPr>
            <p:cNvSpPr txBox="1"/>
            <p:nvPr/>
          </p:nvSpPr>
          <p:spPr>
            <a:xfrm>
              <a:off x="3555861" y="3326095"/>
              <a:ext cx="581229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Okayama</a:t>
              </a: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7DD02F74-E5E8-774D-881F-CAC9EE276FDB}"/>
                </a:ext>
              </a:extLst>
            </p:cNvPr>
            <p:cNvSpPr txBox="1"/>
            <p:nvPr/>
          </p:nvSpPr>
          <p:spPr>
            <a:xfrm>
              <a:off x="4096811" y="3494229"/>
              <a:ext cx="581229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Tottori</a:t>
              </a: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A3A41BEE-5153-0841-AB37-2DA8B1377ACA}"/>
                </a:ext>
              </a:extLst>
            </p:cNvPr>
            <p:cNvSpPr txBox="1"/>
            <p:nvPr/>
          </p:nvSpPr>
          <p:spPr>
            <a:xfrm>
              <a:off x="4698879" y="3336832"/>
              <a:ext cx="581229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Shimane</a:t>
              </a: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B01B81D8-9187-A345-9930-E96848C42141}"/>
                </a:ext>
              </a:extLst>
            </p:cNvPr>
            <p:cNvSpPr txBox="1"/>
            <p:nvPr/>
          </p:nvSpPr>
          <p:spPr>
            <a:xfrm>
              <a:off x="5489688" y="3343207"/>
              <a:ext cx="658535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Ya</a:t>
              </a:r>
              <a:r>
                <a:rPr lang="en-US" altLang="ja-JP" sz="1000" dirty="0">
                  <a:latin typeface="Helvetica" pitchFamily="2" charset="0"/>
                </a:rPr>
                <a:t>maguchi</a:t>
              </a:r>
              <a:endParaRPr kumimoji="1" lang="en-US" altLang="ja-JP" sz="1000" dirty="0">
                <a:latin typeface="Helvetica" pitchFamily="2" charset="0"/>
              </a:endParaRPr>
            </a:p>
          </p:txBody>
        </p: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391C9803-2A56-124C-870F-9FB11F6D066E}"/>
                </a:ext>
              </a:extLst>
            </p:cNvPr>
            <p:cNvCxnSpPr>
              <a:cxnSpLocks/>
            </p:cNvCxnSpPr>
            <p:nvPr/>
          </p:nvCxnSpPr>
          <p:spPr>
            <a:xfrm>
              <a:off x="5865818" y="3170993"/>
              <a:ext cx="0" cy="13566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矢印コネクタ 67">
              <a:extLst>
                <a:ext uri="{FF2B5EF4-FFF2-40B4-BE49-F238E27FC236}">
                  <a16:creationId xmlns:a16="http://schemas.microsoft.com/office/drawing/2014/main" id="{6BBDC074-B0F5-9446-99A8-C03EE0664F3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789191" y="3303102"/>
              <a:ext cx="461614" cy="59204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1AC7F916-563F-F142-8EE8-1EBF87F4819D}"/>
                </a:ext>
              </a:extLst>
            </p:cNvPr>
            <p:cNvSpPr txBox="1"/>
            <p:nvPr/>
          </p:nvSpPr>
          <p:spPr>
            <a:xfrm>
              <a:off x="8110035" y="4139590"/>
              <a:ext cx="581229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Hiroshima</a:t>
              </a: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42049827-5D14-2B47-A967-3C8680E53642}"/>
                </a:ext>
              </a:extLst>
            </p:cNvPr>
            <p:cNvSpPr txBox="1"/>
            <p:nvPr/>
          </p:nvSpPr>
          <p:spPr>
            <a:xfrm>
              <a:off x="5177790" y="3477026"/>
              <a:ext cx="581229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 anchor="ctr" anchorCtr="1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Hiroshima</a:t>
              </a:r>
            </a:p>
          </p:txBody>
        </p:sp>
        <p:pic>
          <p:nvPicPr>
            <p:cNvPr id="71" name="図 70">
              <a:extLst>
                <a:ext uri="{FF2B5EF4-FFF2-40B4-BE49-F238E27FC236}">
                  <a16:creationId xmlns:a16="http://schemas.microsoft.com/office/drawing/2014/main" id="{9DB10653-452B-BE4F-8A1D-E1E6BFFF8C6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038044" y="1909344"/>
              <a:ext cx="305398" cy="299229"/>
            </a:xfrm>
            <a:prstGeom prst="rect">
              <a:avLst/>
            </a:prstGeom>
          </p:spPr>
        </p:pic>
        <p:pic>
          <p:nvPicPr>
            <p:cNvPr id="72" name="図 71">
              <a:extLst>
                <a:ext uri="{FF2B5EF4-FFF2-40B4-BE49-F238E27FC236}">
                  <a16:creationId xmlns:a16="http://schemas.microsoft.com/office/drawing/2014/main" id="{36F3D983-7A6A-5C4F-9549-93C001ACEB3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0053747" y="1291254"/>
              <a:ext cx="305693" cy="299517"/>
            </a:xfrm>
            <a:prstGeom prst="rect">
              <a:avLst/>
            </a:prstGeom>
          </p:spPr>
        </p:pic>
        <p:pic>
          <p:nvPicPr>
            <p:cNvPr id="73" name="図 72">
              <a:extLst>
                <a:ext uri="{FF2B5EF4-FFF2-40B4-BE49-F238E27FC236}">
                  <a16:creationId xmlns:a16="http://schemas.microsoft.com/office/drawing/2014/main" id="{20EE0A11-C413-6D43-8C90-A9257A49B76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954253" y="1119562"/>
              <a:ext cx="305042" cy="298880"/>
            </a:xfrm>
            <a:prstGeom prst="rect">
              <a:avLst/>
            </a:prstGeom>
          </p:spPr>
        </p:pic>
        <p:pic>
          <p:nvPicPr>
            <p:cNvPr id="74" name="図 73">
              <a:extLst>
                <a:ext uri="{FF2B5EF4-FFF2-40B4-BE49-F238E27FC236}">
                  <a16:creationId xmlns:a16="http://schemas.microsoft.com/office/drawing/2014/main" id="{BD6D2850-9C58-3649-8E22-F31CEA8EE3F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0072812" y="2510819"/>
              <a:ext cx="309435" cy="303184"/>
            </a:xfrm>
            <a:prstGeom prst="rect">
              <a:avLst/>
            </a:prstGeom>
          </p:spPr>
        </p:pic>
        <p:pic>
          <p:nvPicPr>
            <p:cNvPr id="75" name="図 74">
              <a:extLst>
                <a:ext uri="{FF2B5EF4-FFF2-40B4-BE49-F238E27FC236}">
                  <a16:creationId xmlns:a16="http://schemas.microsoft.com/office/drawing/2014/main" id="{531B17D6-80DB-5842-9B81-E9DD6AAB709B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8887364" y="1795397"/>
              <a:ext cx="309435" cy="303184"/>
            </a:xfrm>
            <a:prstGeom prst="rect">
              <a:avLst/>
            </a:prstGeom>
          </p:spPr>
        </p:pic>
        <p:pic>
          <p:nvPicPr>
            <p:cNvPr id="76" name="図 75">
              <a:extLst>
                <a:ext uri="{FF2B5EF4-FFF2-40B4-BE49-F238E27FC236}">
                  <a16:creationId xmlns:a16="http://schemas.microsoft.com/office/drawing/2014/main" id="{B6C45BA9-0DC5-C14B-A4DE-E964ECF9F2A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9721284" y="3222142"/>
              <a:ext cx="309434" cy="303182"/>
            </a:xfrm>
            <a:prstGeom prst="rect">
              <a:avLst/>
            </a:prstGeom>
          </p:spPr>
        </p:pic>
        <p:pic>
          <p:nvPicPr>
            <p:cNvPr id="77" name="図 76">
              <a:extLst>
                <a:ext uri="{FF2B5EF4-FFF2-40B4-BE49-F238E27FC236}">
                  <a16:creationId xmlns:a16="http://schemas.microsoft.com/office/drawing/2014/main" id="{47C2541C-CA4D-B646-91E6-5382754BA47C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8400650" y="1823763"/>
              <a:ext cx="309436" cy="303184"/>
            </a:xfrm>
            <a:prstGeom prst="rect">
              <a:avLst/>
            </a:prstGeom>
          </p:spPr>
        </p:pic>
        <p:pic>
          <p:nvPicPr>
            <p:cNvPr id="78" name="図 77">
              <a:extLst>
                <a:ext uri="{FF2B5EF4-FFF2-40B4-BE49-F238E27FC236}">
                  <a16:creationId xmlns:a16="http://schemas.microsoft.com/office/drawing/2014/main" id="{F4535AF2-CA36-2B43-95B9-47A113C4E06B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8227255" y="2312090"/>
              <a:ext cx="309436" cy="303185"/>
            </a:xfrm>
            <a:prstGeom prst="rect">
              <a:avLst/>
            </a:prstGeom>
          </p:spPr>
        </p:pic>
        <p:pic>
          <p:nvPicPr>
            <p:cNvPr id="79" name="図 78">
              <a:extLst>
                <a:ext uri="{FF2B5EF4-FFF2-40B4-BE49-F238E27FC236}">
                  <a16:creationId xmlns:a16="http://schemas.microsoft.com/office/drawing/2014/main" id="{E0523F8B-59D0-E24F-92D3-8578EDBF29B5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7567142" y="2159066"/>
              <a:ext cx="312358" cy="306048"/>
            </a:xfrm>
            <a:prstGeom prst="rect">
              <a:avLst/>
            </a:prstGeom>
          </p:spPr>
        </p:pic>
        <p:pic>
          <p:nvPicPr>
            <p:cNvPr id="80" name="図 79">
              <a:extLst>
                <a:ext uri="{FF2B5EF4-FFF2-40B4-BE49-F238E27FC236}">
                  <a16:creationId xmlns:a16="http://schemas.microsoft.com/office/drawing/2014/main" id="{81C5ED37-4185-1D43-98FB-43B4D6B6C628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7259103" y="2535106"/>
              <a:ext cx="309435" cy="303184"/>
            </a:xfrm>
            <a:prstGeom prst="rect">
              <a:avLst/>
            </a:prstGeom>
          </p:spPr>
        </p:pic>
        <p:pic>
          <p:nvPicPr>
            <p:cNvPr id="81" name="図 80">
              <a:extLst>
                <a:ext uri="{FF2B5EF4-FFF2-40B4-BE49-F238E27FC236}">
                  <a16:creationId xmlns:a16="http://schemas.microsoft.com/office/drawing/2014/main" id="{8FCFC17A-739A-4D4E-A785-5355C44215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8261000" y="3836406"/>
              <a:ext cx="309435" cy="303184"/>
            </a:xfrm>
            <a:prstGeom prst="rect">
              <a:avLst/>
            </a:prstGeom>
          </p:spPr>
        </p:pic>
        <p:pic>
          <p:nvPicPr>
            <p:cNvPr id="82" name="図 81">
              <a:extLst>
                <a:ext uri="{FF2B5EF4-FFF2-40B4-BE49-F238E27FC236}">
                  <a16:creationId xmlns:a16="http://schemas.microsoft.com/office/drawing/2014/main" id="{FF5B361D-0682-DA40-8FC0-3A577AA56BBE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6856986" y="2705494"/>
              <a:ext cx="309435" cy="303184"/>
            </a:xfrm>
            <a:prstGeom prst="rect">
              <a:avLst/>
            </a:prstGeom>
          </p:spPr>
        </p:pic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26722DEC-44D8-D641-B418-001CD7821620}"/>
                </a:ext>
              </a:extLst>
            </p:cNvPr>
            <p:cNvSpPr txBox="1"/>
            <p:nvPr/>
          </p:nvSpPr>
          <p:spPr>
            <a:xfrm>
              <a:off x="347869" y="223746"/>
              <a:ext cx="4667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" altLang="ja-JP" dirty="0">
                  <a:latin typeface="Helvetica" pitchFamily="2" charset="0"/>
                </a:rPr>
                <a:t>(a)</a:t>
              </a:r>
              <a:endParaRPr kumimoji="1" lang="ja-JP" altLang="en-US"/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34FED78E-50B7-B940-B288-35B7CCEF9E05}"/>
                </a:ext>
              </a:extLst>
            </p:cNvPr>
            <p:cNvSpPr txBox="1"/>
            <p:nvPr/>
          </p:nvSpPr>
          <p:spPr>
            <a:xfrm>
              <a:off x="6418400" y="222399"/>
              <a:ext cx="4667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" altLang="ja-JP" dirty="0">
                  <a:latin typeface="Helvetica" pitchFamily="2" charset="0"/>
                </a:rPr>
                <a:t>(b)</a:t>
              </a:r>
              <a:endParaRPr kumimoji="1" lang="ja-JP" altLang="en-US"/>
            </a:p>
          </p:txBody>
        </p: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6E968B4-39FA-0D49-98B2-1F61AAE1B785}"/>
              </a:ext>
            </a:extLst>
          </p:cNvPr>
          <p:cNvSpPr txBox="1"/>
          <p:nvPr/>
        </p:nvSpPr>
        <p:spPr>
          <a:xfrm>
            <a:off x="168965" y="4363383"/>
            <a:ext cx="1179112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Supplementary Figure S3.</a:t>
            </a:r>
            <a:r>
              <a:rPr lang="en-US" altLang="ja-JP" sz="1400" dirty="0">
                <a:latin typeface="Helvetica" pitchFamily="2" charset="0"/>
              </a:rPr>
              <a:t> (</a:t>
            </a:r>
            <a:r>
              <a:rPr lang="en-US" altLang="ja-JP" sz="1400" b="1" dirty="0">
                <a:latin typeface="Helvetica" pitchFamily="2" charset="0"/>
              </a:rPr>
              <a:t>a</a:t>
            </a:r>
            <a:r>
              <a:rPr lang="en-US" altLang="ja-JP" sz="1400" dirty="0">
                <a:latin typeface="Helvetica" pitchFamily="2" charset="0"/>
              </a:rPr>
              <a:t>) Bayesian estimates of population structure based on SSR data for the whole dataset including 3 cultivar populations, 29 wild populations, and the FTBC gene bank collection. The bar plots include only the FTBC collection. The CLUMPAK online tool (</a:t>
            </a:r>
            <a:r>
              <a:rPr lang="en-US" altLang="ja-JP" sz="1400" dirty="0">
                <a:latin typeface="Helvetica" pitchFamily="2" charset="0"/>
                <a:hlinkClick r:id="rId19"/>
              </a:rPr>
              <a:t>http://clumpak.tau.ac.il/</a:t>
            </a:r>
            <a:r>
              <a:rPr lang="en-US" altLang="ja-JP" sz="1400" dirty="0">
                <a:latin typeface="Helvetica" pitchFamily="2" charset="0"/>
              </a:rPr>
              <a:t>)</a:t>
            </a:r>
            <a:r>
              <a:rPr lang="en-US" altLang="ja-JP" sz="1400" baseline="30000" dirty="0">
                <a:latin typeface="Helvetica" pitchFamily="2" charset="0"/>
              </a:rPr>
              <a:t>66</a:t>
            </a:r>
            <a:r>
              <a:rPr lang="en-US" altLang="ja-JP" sz="1400" dirty="0">
                <a:latin typeface="Helvetica" pitchFamily="2" charset="0"/>
              </a:rPr>
              <a:t> was applied to graphically display the results produced by STRUCTURE. (</a:t>
            </a:r>
            <a:r>
              <a:rPr lang="en-US" altLang="ja-JP" sz="1400" b="1" dirty="0">
                <a:latin typeface="Helvetica" pitchFamily="2" charset="0"/>
              </a:rPr>
              <a:t>b</a:t>
            </a:r>
            <a:r>
              <a:rPr lang="en-US" altLang="ja-JP" sz="1400" dirty="0">
                <a:latin typeface="Helvetica" pitchFamily="2" charset="0"/>
              </a:rPr>
              <a:t>) Pie charts indicate the clusters identified in STRUCTURE (</a:t>
            </a:r>
            <a:r>
              <a:rPr lang="en-US" altLang="ja-JP" sz="1400" i="1" dirty="0">
                <a:latin typeface="Helvetica" pitchFamily="2" charset="0"/>
              </a:rPr>
              <a:t>K</a:t>
            </a:r>
            <a:r>
              <a:rPr lang="en-US" altLang="ja-JP" sz="1400" dirty="0">
                <a:latin typeface="Helvetica" pitchFamily="2" charset="0"/>
              </a:rPr>
              <a:t> = 5) for each geographic region. The colors in the pie charts are based on those used in Figure 2. The map was created using </a:t>
            </a:r>
            <a:r>
              <a:rPr lang="en-US" altLang="ja-JP" sz="1400" dirty="0" err="1">
                <a:latin typeface="Helvetica" pitchFamily="2" charset="0"/>
              </a:rPr>
              <a:t>MapChart</a:t>
            </a:r>
            <a:r>
              <a:rPr lang="en-US" altLang="ja-JP" sz="1400">
                <a:latin typeface="Helvetica" pitchFamily="2" charset="0"/>
              </a:rPr>
              <a:t> (</a:t>
            </a:r>
            <a:r>
              <a:rPr lang="en-US" altLang="ja-JP" sz="1400" dirty="0">
                <a:latin typeface="Helvetica" pitchFamily="2" charset="0"/>
                <a:hlinkClick r:id="rId19"/>
              </a:rPr>
              <a:t>https://mapchart.net</a:t>
            </a:r>
            <a:r>
              <a:rPr lang="en-US" altLang="ja-JP" sz="1400" dirty="0">
                <a:latin typeface="Helvetica" pitchFamily="2" charset="0"/>
              </a:rPr>
              <a:t>.) </a:t>
            </a:r>
            <a:endParaRPr kumimoji="1" lang="ja-JP" altLang="en-US" sz="14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8596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</TotalTime>
  <Words>821</Words>
  <Application>Microsoft Macintosh PowerPoint</Application>
  <PresentationFormat>ワイド画面</PresentationFormat>
  <Paragraphs>76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游ゴシック</vt:lpstr>
      <vt:lpstr>游ゴシック Light</vt:lpstr>
      <vt:lpstr>Arial</vt:lpstr>
      <vt:lpstr>Century</vt:lpstr>
      <vt:lpstr>Helvetica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西尾　聡悟</dc:creator>
  <cp:lastModifiedBy>西尾　聡悟</cp:lastModifiedBy>
  <cp:revision>36</cp:revision>
  <dcterms:created xsi:type="dcterms:W3CDTF">2019-08-08T08:38:11Z</dcterms:created>
  <dcterms:modified xsi:type="dcterms:W3CDTF">2020-12-10T11:49:46Z</dcterms:modified>
</cp:coreProperties>
</file>